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0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5CFD262-C4FC-4AB2-B5C8-4F442A53D108}" v="3" dt="2024-11-14T09:13:33.6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daf Naqvi" userId="8f91277e-8741-4995-819e-50b4e5326a9f" providerId="ADAL" clId="{C5CFD262-C4FC-4AB2-B5C8-4F442A53D108}"/>
    <pc:docChg chg="custSel delSld modSld">
      <pc:chgData name="Sadaf Naqvi" userId="8f91277e-8741-4995-819e-50b4e5326a9f" providerId="ADAL" clId="{C5CFD262-C4FC-4AB2-B5C8-4F442A53D108}" dt="2024-11-14T09:13:42.781" v="199" actId="313"/>
      <pc:docMkLst>
        <pc:docMk/>
      </pc:docMkLst>
      <pc:sldChg chg="addSp delSp modSp del mod">
        <pc:chgData name="Sadaf Naqvi" userId="8f91277e-8741-4995-819e-50b4e5326a9f" providerId="ADAL" clId="{C5CFD262-C4FC-4AB2-B5C8-4F442A53D108}" dt="2024-11-14T09:12:35.671" v="193" actId="2696"/>
        <pc:sldMkLst>
          <pc:docMk/>
          <pc:sldMk cId="2828968604" sldId="257"/>
        </pc:sldMkLst>
        <pc:spChg chg="add mod">
          <ac:chgData name="Sadaf Naqvi" userId="8f91277e-8741-4995-819e-50b4e5326a9f" providerId="ADAL" clId="{C5CFD262-C4FC-4AB2-B5C8-4F442A53D108}" dt="2024-11-14T09:08:56.459" v="155" actId="255"/>
          <ac:spMkLst>
            <pc:docMk/>
            <pc:sldMk cId="2828968604" sldId="257"/>
            <ac:spMk id="2" creationId="{165C228C-E401-DB54-757C-0DB575485BFB}"/>
          </ac:spMkLst>
        </pc:spChg>
        <pc:spChg chg="del">
          <ac:chgData name="Sadaf Naqvi" userId="8f91277e-8741-4995-819e-50b4e5326a9f" providerId="ADAL" clId="{C5CFD262-C4FC-4AB2-B5C8-4F442A53D108}" dt="2024-11-06T12:54:03.500" v="1" actId="478"/>
          <ac:spMkLst>
            <pc:docMk/>
            <pc:sldMk cId="2828968604" sldId="257"/>
            <ac:spMk id="2" creationId="{CA94FDE0-C43A-6935-5F94-1F8DD6993D6F}"/>
          </ac:spMkLst>
        </pc:spChg>
        <pc:spChg chg="add del mod">
          <ac:chgData name="Sadaf Naqvi" userId="8f91277e-8741-4995-819e-50b4e5326a9f" providerId="ADAL" clId="{C5CFD262-C4FC-4AB2-B5C8-4F442A53D108}" dt="2024-11-06T12:54:05.819" v="2" actId="478"/>
          <ac:spMkLst>
            <pc:docMk/>
            <pc:sldMk cId="2828968604" sldId="257"/>
            <ac:spMk id="5" creationId="{0B870E8E-1E9A-C331-5602-0730EF54AE81}"/>
          </ac:spMkLst>
        </pc:spChg>
        <pc:picChg chg="mod">
          <ac:chgData name="Sadaf Naqvi" userId="8f91277e-8741-4995-819e-50b4e5326a9f" providerId="ADAL" clId="{C5CFD262-C4FC-4AB2-B5C8-4F442A53D108}" dt="2024-11-14T08:43:22.911" v="4" actId="1076"/>
          <ac:picMkLst>
            <pc:docMk/>
            <pc:sldMk cId="2828968604" sldId="257"/>
            <ac:picMk id="4" creationId="{CF2CE9F8-B3F2-BF0A-ABD6-3D98F519F155}"/>
          </ac:picMkLst>
        </pc:picChg>
      </pc:sldChg>
      <pc:sldChg chg="del">
        <pc:chgData name="Sadaf Naqvi" userId="8f91277e-8741-4995-819e-50b4e5326a9f" providerId="ADAL" clId="{C5CFD262-C4FC-4AB2-B5C8-4F442A53D108}" dt="2024-11-06T12:50:24.957" v="0" actId="2696"/>
        <pc:sldMkLst>
          <pc:docMk/>
          <pc:sldMk cId="2496051410" sldId="258"/>
        </pc:sldMkLst>
      </pc:sldChg>
      <pc:sldChg chg="addSp delSp modSp mod">
        <pc:chgData name="Sadaf Naqvi" userId="8f91277e-8741-4995-819e-50b4e5326a9f" providerId="ADAL" clId="{C5CFD262-C4FC-4AB2-B5C8-4F442A53D108}" dt="2024-11-14T09:13:42.781" v="199" actId="313"/>
        <pc:sldMkLst>
          <pc:docMk/>
          <pc:sldMk cId="2400442955" sldId="4071"/>
        </pc:sldMkLst>
        <pc:spChg chg="mod">
          <ac:chgData name="Sadaf Naqvi" userId="8f91277e-8741-4995-819e-50b4e5326a9f" providerId="ADAL" clId="{C5CFD262-C4FC-4AB2-B5C8-4F442A53D108}" dt="2024-11-14T09:11:44.514" v="170" actId="20577"/>
          <ac:spMkLst>
            <pc:docMk/>
            <pc:sldMk cId="2400442955" sldId="4071"/>
            <ac:spMk id="3" creationId="{DFE2AD2D-F537-5DEA-9B87-3BB245032523}"/>
          </ac:spMkLst>
        </pc:spChg>
        <pc:spChg chg="mod">
          <ac:chgData name="Sadaf Naqvi" userId="8f91277e-8741-4995-819e-50b4e5326a9f" providerId="ADAL" clId="{C5CFD262-C4FC-4AB2-B5C8-4F442A53D108}" dt="2024-11-14T09:11:36.216" v="163" actId="20577"/>
          <ac:spMkLst>
            <pc:docMk/>
            <pc:sldMk cId="2400442955" sldId="4071"/>
            <ac:spMk id="5" creationId="{43032C6F-D3A3-BF91-7C60-C55C29D3B5AB}"/>
          </ac:spMkLst>
        </pc:spChg>
        <pc:spChg chg="add mod">
          <ac:chgData name="Sadaf Naqvi" userId="8f91277e-8741-4995-819e-50b4e5326a9f" providerId="ADAL" clId="{C5CFD262-C4FC-4AB2-B5C8-4F442A53D108}" dt="2024-11-14T09:11:28.110" v="159" actId="255"/>
          <ac:spMkLst>
            <pc:docMk/>
            <pc:sldMk cId="2400442955" sldId="4071"/>
            <ac:spMk id="9" creationId="{620F07D0-D968-DFE3-4A91-05D0B015E9F1}"/>
          </ac:spMkLst>
        </pc:spChg>
        <pc:spChg chg="mod">
          <ac:chgData name="Sadaf Naqvi" userId="8f91277e-8741-4995-819e-50b4e5326a9f" providerId="ADAL" clId="{C5CFD262-C4FC-4AB2-B5C8-4F442A53D108}" dt="2024-11-14T09:12:41.385" v="194" actId="1076"/>
          <ac:spMkLst>
            <pc:docMk/>
            <pc:sldMk cId="2400442955" sldId="4071"/>
            <ac:spMk id="24" creationId="{8FF9362F-613D-1FE3-D171-242A6692C61A}"/>
          </ac:spMkLst>
        </pc:spChg>
        <pc:spChg chg="mod">
          <ac:chgData name="Sadaf Naqvi" userId="8f91277e-8741-4995-819e-50b4e5326a9f" providerId="ADAL" clId="{C5CFD262-C4FC-4AB2-B5C8-4F442A53D108}" dt="2024-11-14T09:11:31.139" v="160" actId="1076"/>
          <ac:spMkLst>
            <pc:docMk/>
            <pc:sldMk cId="2400442955" sldId="4071"/>
            <ac:spMk id="33" creationId="{81DEC6CF-96AB-ADAE-F75A-BCEA28903B7D}"/>
          </ac:spMkLst>
        </pc:spChg>
        <pc:spChg chg="mod">
          <ac:chgData name="Sadaf Naqvi" userId="8f91277e-8741-4995-819e-50b4e5326a9f" providerId="ADAL" clId="{C5CFD262-C4FC-4AB2-B5C8-4F442A53D108}" dt="2024-11-14T09:13:42.781" v="199" actId="313"/>
          <ac:spMkLst>
            <pc:docMk/>
            <pc:sldMk cId="2400442955" sldId="4071"/>
            <ac:spMk id="35" creationId="{62CF8CD7-01BA-DD57-EA01-ACBF63D9CCEB}"/>
          </ac:spMkLst>
        </pc:spChg>
        <pc:grpChg chg="del">
          <ac:chgData name="Sadaf Naqvi" userId="8f91277e-8741-4995-819e-50b4e5326a9f" providerId="ADAL" clId="{C5CFD262-C4FC-4AB2-B5C8-4F442A53D108}" dt="2024-11-14T09:13:31.628" v="195" actId="478"/>
          <ac:grpSpMkLst>
            <pc:docMk/>
            <pc:sldMk cId="2400442955" sldId="4071"/>
            <ac:grpSpMk id="56" creationId="{232FFDCC-26EC-B42F-5AD1-BB8F527998FF}"/>
          </ac:grpSpMkLst>
        </pc:grpChg>
        <pc:picChg chg="add mod">
          <ac:chgData name="Sadaf Naqvi" userId="8f91277e-8741-4995-819e-50b4e5326a9f" providerId="ADAL" clId="{C5CFD262-C4FC-4AB2-B5C8-4F442A53D108}" dt="2024-11-14T09:13:37.888" v="198" actId="1076"/>
          <ac:picMkLst>
            <pc:docMk/>
            <pc:sldMk cId="2400442955" sldId="4071"/>
            <ac:picMk id="10" creationId="{E0334F0C-FEBF-5014-00C7-F55109168637}"/>
          </ac:picMkLst>
        </pc:picChg>
        <pc:picChg chg="topLvl">
          <ac:chgData name="Sadaf Naqvi" userId="8f91277e-8741-4995-819e-50b4e5326a9f" providerId="ADAL" clId="{C5CFD262-C4FC-4AB2-B5C8-4F442A53D108}" dt="2024-11-14T09:13:31.628" v="195" actId="478"/>
          <ac:picMkLst>
            <pc:docMk/>
            <pc:sldMk cId="2400442955" sldId="4071"/>
            <ac:picMk id="45" creationId="{09F60E93-C9B0-EEF6-BE89-4785CC81B9AB}"/>
          </ac:picMkLst>
        </pc:picChg>
        <pc:picChg chg="del topLvl">
          <ac:chgData name="Sadaf Naqvi" userId="8f91277e-8741-4995-819e-50b4e5326a9f" providerId="ADAL" clId="{C5CFD262-C4FC-4AB2-B5C8-4F442A53D108}" dt="2024-11-14T09:13:31.628" v="195" actId="478"/>
          <ac:picMkLst>
            <pc:docMk/>
            <pc:sldMk cId="2400442955" sldId="4071"/>
            <ac:picMk id="54" creationId="{745B2223-2457-FC1B-4AE2-BFCBF827A1AC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68C48D-A486-6E89-6C7A-DC833FB704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09A8B7-7800-1F97-2344-E131617DFD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366FD-B4DB-7EB3-69FA-70BDCA504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64FAAD-A448-519A-AC74-50CBFBD97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9D17C6-AFC6-52D8-5D09-37C200C8C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4230053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0367E-44C3-D1F7-62F1-54693037B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A70232-D37C-8C45-3A9C-D7D5350FCB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FFC4D-41FB-8A01-C48C-9E7AB1434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D29CD3-BA08-0FC5-BB65-2EF7CAEF8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00B12C-0D6F-5AC1-F8ED-37D2569C3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307044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D219A9-A91D-C7A5-6CBD-D0B41679C7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E5AA97-77DB-C15D-C0D5-957D75A955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BCB0CF-3EDD-7C6D-DEB6-7549EFB1D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8D1FB4-5087-A930-5B78-8BF082608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24C854-BD81-F980-759A-021C54D2D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417246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C1290-586E-2DDF-F1DA-C4EA47D6C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49588F-3FF8-65AA-A891-CCD573DF01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FCD04-BFDA-C0C3-43C4-94C469968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1D8EFA-A88B-96B4-FF06-8B64917C1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1DC422-253A-BB67-0AF2-1E99BEA21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924414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A28A11-838D-D2DD-55B4-6C63FA743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D0C543-2535-07EB-B2F0-3312E7BF01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B32F60-B38A-792B-5C0F-5D7DDFC8F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9901F2-3097-0969-8A91-238962959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00D6CD-716B-DDAE-9196-7A976DC3A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200760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ACE48-9899-EED3-1FC4-4840D8326C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3CD23E-A8B0-A862-1CD6-9F19A2B644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BA0B39-F16D-D778-642D-3F7907FC26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30BB97-F3DD-F112-1284-8E370C5F0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E3B947-9CFA-9355-9938-83716C32E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094360-C2EE-15FC-9D07-C95C64E55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178834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09226A-3E98-6E2C-6076-76A840B382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3905A3-2FD2-E093-6C79-E6082BC952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AD6E32-8D3C-04CF-B236-F1EB000A8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6B2E07-3657-7CE3-071E-AE71849719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B4621F-129A-4765-2034-2AC1BC7AF7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77AA78-6B7C-05E0-DBD1-54C009C86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D5CBAC-CF07-E87F-EA51-5447FD63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04EC99-3FC4-2CCC-AB2C-480CF7ACC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738471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9A408-574A-C2D3-DBE3-4FBB9E05F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93148F-C0CD-D23A-2717-216D09552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D63BCC-DBA8-D378-4D42-0F379F7DD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DE92133-D309-DEED-0999-67A24FC01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942059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E16AF3-921C-DF98-4624-AC09DE867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197E7C-B0F6-F9A3-8683-4A9337C17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450C66-C365-F829-171C-02C62AA33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981753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EDF864-A919-6F29-1BD7-5CFEB91D1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10DAE7-6B29-965F-37F8-149486260B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EABF2F-38E4-0EE4-9996-53BFE050E6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89D6B5-9D01-F30D-4159-55F9DBD59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ADFDA9-F64B-1FFD-789B-2C0A84362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1AE6F0-13C2-3050-C08A-0E61BCD8A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53463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F4C22-D012-ADED-149E-2EECDBE47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A5229D-5729-4C84-A459-AC2F81ADA9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9B3EC1-9AC3-71DC-3152-2C31E60DDF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37BE77-09DB-BE68-F16D-51E0EF033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159977-7F6B-276B-0522-F5E17DEF0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7D6283-0C91-BE41-CDC0-5822DEB60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821484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43B1B0-CD18-7AA8-63A5-F312D126B9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9DD10-F90E-FC0F-E0DE-6A4CB3E626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EA191F-B78C-5713-36C0-FC9FA45A58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28C02B-9201-A477-6705-D22C8BD4B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321A6F-A45E-93A5-4616-55CCBD971C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576806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44">
            <a:extLst>
              <a:ext uri="{FF2B5EF4-FFF2-40B4-BE49-F238E27FC236}">
                <a16:creationId xmlns:a16="http://schemas.microsoft.com/office/drawing/2014/main" id="{09F60E93-C9B0-EEF6-BE89-4785CC81B9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0082" y="2389104"/>
            <a:ext cx="4591918" cy="2940484"/>
          </a:xfrm>
          <a:prstGeom prst="rect">
            <a:avLst/>
          </a:prstGeom>
        </p:spPr>
      </p:pic>
      <p:sp>
        <p:nvSpPr>
          <p:cNvPr id="25" name="Rectangle: Rounded Corners 24">
            <a:extLst>
              <a:ext uri="{FF2B5EF4-FFF2-40B4-BE49-F238E27FC236}">
                <a16:creationId xmlns:a16="http://schemas.microsoft.com/office/drawing/2014/main" id="{78E0CCDF-4196-BBA3-C069-1BE7F45BF421}"/>
              </a:ext>
            </a:extLst>
          </p:cNvPr>
          <p:cNvSpPr/>
          <p:nvPr/>
        </p:nvSpPr>
        <p:spPr>
          <a:xfrm>
            <a:off x="2567754" y="2284641"/>
            <a:ext cx="4273277" cy="2659222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Flowchart: Magnetic Disk 4">
            <a:extLst>
              <a:ext uri="{FF2B5EF4-FFF2-40B4-BE49-F238E27FC236}">
                <a16:creationId xmlns:a16="http://schemas.microsoft.com/office/drawing/2014/main" id="{43032C6F-D3A3-BF91-7C60-C55C29D3B5AB}"/>
              </a:ext>
            </a:extLst>
          </p:cNvPr>
          <p:cNvSpPr/>
          <p:nvPr/>
        </p:nvSpPr>
        <p:spPr>
          <a:xfrm>
            <a:off x="409820" y="2118092"/>
            <a:ext cx="991554" cy="1216709"/>
          </a:xfrm>
          <a:prstGeom prst="flowChartMagneticDisk">
            <a:avLst/>
          </a:prstGeom>
          <a:solidFill>
            <a:schemeClr val="accent6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EHR</a:t>
            </a:r>
          </a:p>
        </p:txBody>
      </p:sp>
      <p:sp>
        <p:nvSpPr>
          <p:cNvPr id="3" name="Flowchart: Magnetic Disk 2">
            <a:extLst>
              <a:ext uri="{FF2B5EF4-FFF2-40B4-BE49-F238E27FC236}">
                <a16:creationId xmlns:a16="http://schemas.microsoft.com/office/drawing/2014/main" id="{DFE2AD2D-F537-5DEA-9B87-3BB245032523}"/>
              </a:ext>
            </a:extLst>
          </p:cNvPr>
          <p:cNvSpPr/>
          <p:nvPr/>
        </p:nvSpPr>
        <p:spPr>
          <a:xfrm>
            <a:off x="409820" y="3717653"/>
            <a:ext cx="991553" cy="1216709"/>
          </a:xfrm>
          <a:prstGeom prst="flowChartMagneticDisk">
            <a:avLst/>
          </a:prstGeom>
          <a:solidFill>
            <a:schemeClr val="accent6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HR Data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81DEC6CF-96AB-ADAE-F75A-BCEA28903B7D}"/>
              </a:ext>
            </a:extLst>
          </p:cNvPr>
          <p:cNvSpPr/>
          <p:nvPr/>
        </p:nvSpPr>
        <p:spPr>
          <a:xfrm>
            <a:off x="409820" y="1326654"/>
            <a:ext cx="1738645" cy="470536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Data Sources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3E0283E-0BCA-82CA-A329-C793D980F6C0}"/>
              </a:ext>
            </a:extLst>
          </p:cNvPr>
          <p:cNvSpPr/>
          <p:nvPr/>
        </p:nvSpPr>
        <p:spPr>
          <a:xfrm>
            <a:off x="3470336" y="825823"/>
            <a:ext cx="2312239" cy="470536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Data Staging Area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62CF8CD7-01BA-DD57-EA01-ACBF63D9CCEB}"/>
              </a:ext>
            </a:extLst>
          </p:cNvPr>
          <p:cNvSpPr/>
          <p:nvPr/>
        </p:nvSpPr>
        <p:spPr>
          <a:xfrm>
            <a:off x="7600082" y="825823"/>
            <a:ext cx="4364661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Real time Dashboard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9B428302-6B81-04A6-A8BD-69DFB897C2D7}"/>
              </a:ext>
            </a:extLst>
          </p:cNvPr>
          <p:cNvCxnSpPr>
            <a:cxnSpLocks/>
          </p:cNvCxnSpPr>
          <p:nvPr/>
        </p:nvCxnSpPr>
        <p:spPr>
          <a:xfrm>
            <a:off x="1401373" y="4350309"/>
            <a:ext cx="99155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A528FAD6-796E-EBEF-C518-EAC5351D4BDC}"/>
              </a:ext>
            </a:extLst>
          </p:cNvPr>
          <p:cNvSpPr txBox="1"/>
          <p:nvPr/>
        </p:nvSpPr>
        <p:spPr>
          <a:xfrm>
            <a:off x="1344139" y="4048921"/>
            <a:ext cx="1157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Web Servic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49DEFCA-D8D3-A9B6-DABE-FCC8948274E8}"/>
              </a:ext>
            </a:extLst>
          </p:cNvPr>
          <p:cNvSpPr txBox="1"/>
          <p:nvPr/>
        </p:nvSpPr>
        <p:spPr>
          <a:xfrm>
            <a:off x="1708032" y="2590850"/>
            <a:ext cx="506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TLs</a:t>
            </a:r>
          </a:p>
        </p:txBody>
      </p:sp>
      <p:sp>
        <p:nvSpPr>
          <p:cNvPr id="22" name="Flowchart: Magnetic Disk 21">
            <a:extLst>
              <a:ext uri="{FF2B5EF4-FFF2-40B4-BE49-F238E27FC236}">
                <a16:creationId xmlns:a16="http://schemas.microsoft.com/office/drawing/2014/main" id="{1EE7F21F-5B9D-1DDC-EF48-39DB9EFB9B84}"/>
              </a:ext>
            </a:extLst>
          </p:cNvPr>
          <p:cNvSpPr/>
          <p:nvPr/>
        </p:nvSpPr>
        <p:spPr>
          <a:xfrm>
            <a:off x="3626017" y="2510186"/>
            <a:ext cx="2156558" cy="821850"/>
          </a:xfrm>
          <a:prstGeom prst="flowChartMagneticDisk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FF9362F-613D-1FE3-D171-242A6692C61A}"/>
              </a:ext>
            </a:extLst>
          </p:cNvPr>
          <p:cNvSpPr txBox="1"/>
          <p:nvPr/>
        </p:nvSpPr>
        <p:spPr>
          <a:xfrm>
            <a:off x="4038743" y="2707285"/>
            <a:ext cx="1331107" cy="332143"/>
          </a:xfrm>
          <a:prstGeom prst="rect">
            <a:avLst/>
          </a:prstGeom>
          <a:noFill/>
          <a:ln>
            <a:solidFill>
              <a:schemeClr val="tx2">
                <a:lumMod val="20000"/>
                <a:lumOff val="8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EI Database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82BC385-10CE-D0DF-0C51-9F5CE6DE81DD}"/>
              </a:ext>
            </a:extLst>
          </p:cNvPr>
          <p:cNvSpPr txBox="1"/>
          <p:nvPr/>
        </p:nvSpPr>
        <p:spPr>
          <a:xfrm>
            <a:off x="4038743" y="1922693"/>
            <a:ext cx="1331107" cy="332143"/>
          </a:xfrm>
          <a:prstGeom prst="rect">
            <a:avLst/>
          </a:prstGeom>
          <a:noFill/>
          <a:ln>
            <a:solidFill>
              <a:schemeClr val="accent3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EI Server</a:t>
            </a:r>
          </a:p>
        </p:txBody>
      </p:sp>
      <p:sp>
        <p:nvSpPr>
          <p:cNvPr id="8" name="Cube 7">
            <a:extLst>
              <a:ext uri="{FF2B5EF4-FFF2-40B4-BE49-F238E27FC236}">
                <a16:creationId xmlns:a16="http://schemas.microsoft.com/office/drawing/2014/main" id="{E149314F-C637-78ED-4A9A-CC0BB9852EC0}"/>
              </a:ext>
            </a:extLst>
          </p:cNvPr>
          <p:cNvSpPr/>
          <p:nvPr/>
        </p:nvSpPr>
        <p:spPr>
          <a:xfrm>
            <a:off x="3597855" y="3769034"/>
            <a:ext cx="2353159" cy="867550"/>
          </a:xfrm>
          <a:prstGeom prst="cub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PHC Analytics Data Mart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84AA5A69-ACFF-5706-D86C-30054BB38E26}"/>
              </a:ext>
            </a:extLst>
          </p:cNvPr>
          <p:cNvCxnSpPr>
            <a:cxnSpLocks/>
          </p:cNvCxnSpPr>
          <p:nvPr/>
        </p:nvCxnSpPr>
        <p:spPr>
          <a:xfrm>
            <a:off x="4693439" y="3326964"/>
            <a:ext cx="0" cy="333259"/>
          </a:xfrm>
          <a:prstGeom prst="straightConnector1">
            <a:avLst/>
          </a:prstGeom>
          <a:ln>
            <a:solidFill>
              <a:schemeClr val="bg1">
                <a:lumMod val="9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2461A830-CFAE-F455-986F-A4AEA945657D}"/>
              </a:ext>
            </a:extLst>
          </p:cNvPr>
          <p:cNvCxnSpPr>
            <a:cxnSpLocks/>
          </p:cNvCxnSpPr>
          <p:nvPr/>
        </p:nvCxnSpPr>
        <p:spPr>
          <a:xfrm>
            <a:off x="1401373" y="2875989"/>
            <a:ext cx="99155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21F584E-7384-9858-0542-94AF9F327D22}"/>
              </a:ext>
            </a:extLst>
          </p:cNvPr>
          <p:cNvCxnSpPr>
            <a:cxnSpLocks/>
          </p:cNvCxnSpPr>
          <p:nvPr/>
        </p:nvCxnSpPr>
        <p:spPr>
          <a:xfrm>
            <a:off x="6841031" y="3717653"/>
            <a:ext cx="9022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: Rounded Corners 56">
            <a:extLst>
              <a:ext uri="{FF2B5EF4-FFF2-40B4-BE49-F238E27FC236}">
                <a16:creationId xmlns:a16="http://schemas.microsoft.com/office/drawing/2014/main" id="{D8B8B9FB-E1C5-CBC4-CFB0-3E999ABEA84A}"/>
              </a:ext>
            </a:extLst>
          </p:cNvPr>
          <p:cNvSpPr/>
          <p:nvPr/>
        </p:nvSpPr>
        <p:spPr>
          <a:xfrm>
            <a:off x="2567754" y="5380861"/>
            <a:ext cx="4273277" cy="610496"/>
          </a:xfrm>
          <a:prstGeom prst="round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ML Pipeline (No Show Model)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E39A34D0-0D36-2C42-300B-35BD470811FF}"/>
              </a:ext>
            </a:extLst>
          </p:cNvPr>
          <p:cNvSpPr/>
          <p:nvPr/>
        </p:nvSpPr>
        <p:spPr>
          <a:xfrm>
            <a:off x="3266312" y="6228043"/>
            <a:ext cx="2720296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Intelligence Layer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7C41BFBE-17A3-80B4-9E61-9CC1EA9E1B4F}"/>
              </a:ext>
            </a:extLst>
          </p:cNvPr>
          <p:cNvCxnSpPr>
            <a:cxnSpLocks/>
          </p:cNvCxnSpPr>
          <p:nvPr/>
        </p:nvCxnSpPr>
        <p:spPr>
          <a:xfrm flipV="1">
            <a:off x="4704296" y="5059234"/>
            <a:ext cx="0" cy="409469"/>
          </a:xfrm>
          <a:prstGeom prst="straightConnector1">
            <a:avLst/>
          </a:prstGeom>
          <a:ln>
            <a:solidFill>
              <a:srgbClr val="ED7D3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620F07D0-D968-DFE3-4A91-05D0B015E9F1}"/>
              </a:ext>
            </a:extLst>
          </p:cNvPr>
          <p:cNvSpPr txBox="1"/>
          <p:nvPr/>
        </p:nvSpPr>
        <p:spPr>
          <a:xfrm>
            <a:off x="550616" y="56879"/>
            <a:ext cx="1096167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dirty="0"/>
              <a:t>Figure 1: Data Architecture diagram representing the layers of data transition from source of information till </a:t>
            </a:r>
          </a:p>
          <a:p>
            <a:r>
              <a:rPr lang="en-US" sz="2000" dirty="0"/>
              <a:t>the dashboard</a:t>
            </a:r>
            <a:endParaRPr lang="en-AE" sz="2000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0334F0C-FEBF-5014-00C7-F551091686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63336" y="2802147"/>
            <a:ext cx="3326151" cy="1716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0442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</TotalTime>
  <Words>50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daf Naqvi</dc:creator>
  <cp:lastModifiedBy>Sadaf Naqvi</cp:lastModifiedBy>
  <cp:revision>2</cp:revision>
  <dcterms:created xsi:type="dcterms:W3CDTF">2024-11-06T09:04:20Z</dcterms:created>
  <dcterms:modified xsi:type="dcterms:W3CDTF">2024-11-14T09:13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3c76ce46-357f-46de-88d6-77b9bbb83c46_Enabled">
    <vt:lpwstr>true</vt:lpwstr>
  </property>
  <property fmtid="{D5CDD505-2E9C-101B-9397-08002B2CF9AE}" pid="3" name="MSIP_Label_3c76ce46-357f-46de-88d6-77b9bbb83c46_SetDate">
    <vt:lpwstr>2024-11-06T09:05:46Z</vt:lpwstr>
  </property>
  <property fmtid="{D5CDD505-2E9C-101B-9397-08002B2CF9AE}" pid="4" name="MSIP_Label_3c76ce46-357f-46de-88d6-77b9bbb83c46_Method">
    <vt:lpwstr>Privileged</vt:lpwstr>
  </property>
  <property fmtid="{D5CDD505-2E9C-101B-9397-08002B2CF9AE}" pid="5" name="MSIP_Label_3c76ce46-357f-46de-88d6-77b9bbb83c46_Name">
    <vt:lpwstr>Public</vt:lpwstr>
  </property>
  <property fmtid="{D5CDD505-2E9C-101B-9397-08002B2CF9AE}" pid="6" name="MSIP_Label_3c76ce46-357f-46de-88d6-77b9bbb83c46_SiteId">
    <vt:lpwstr>4e2c6054-71cb-48f1-bd6c-3a9705aca71b</vt:lpwstr>
  </property>
  <property fmtid="{D5CDD505-2E9C-101B-9397-08002B2CF9AE}" pid="7" name="MSIP_Label_3c76ce46-357f-46de-88d6-77b9bbb83c46_ActionId">
    <vt:lpwstr>6109e0eb-3837-46db-a36e-5089aca50507</vt:lpwstr>
  </property>
  <property fmtid="{D5CDD505-2E9C-101B-9397-08002B2CF9AE}" pid="8" name="MSIP_Label_3c76ce46-357f-46de-88d6-77b9bbb83c46_ContentBits">
    <vt:lpwstr>0</vt:lpwstr>
  </property>
</Properties>
</file>